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0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92" d="100"/>
          <a:sy n="92" d="100"/>
        </p:scale>
        <p:origin x="84" y="5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285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05178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6935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81911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25943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604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973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6550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91765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8357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0050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EB9CF-DF18-49BE-A2D2-21D8A81FBF53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9/6/1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9767D-D252-4E67-989C-B62664DDFB0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10599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/>
          <p:cNvGrpSpPr/>
          <p:nvPr/>
        </p:nvGrpSpPr>
        <p:grpSpPr>
          <a:xfrm>
            <a:off x="2639617" y="2348880"/>
            <a:ext cx="6990055" cy="2600960"/>
            <a:chOff x="1259632" y="1764144"/>
            <a:chExt cx="6990055" cy="2600960"/>
          </a:xfrm>
        </p:grpSpPr>
        <p:pic>
          <p:nvPicPr>
            <p:cNvPr id="2050" name="Picture 2" descr="C:\Users\Nakano\Downloads\18-9872 x20.jpg"/>
            <p:cNvPicPr>
              <a:picLocks noChangeAspect="1" noChangeArrowheads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59632" y="1764144"/>
              <a:ext cx="3454400" cy="26009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C:\Users\Nakano\Downloads\18-9872 MT x20.jpg"/>
            <p:cNvPicPr>
              <a:picLocks noChangeAspect="1" noChangeArrowheads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95287" y="1764144"/>
              <a:ext cx="3454400" cy="26009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6" name="テキスト ボックス 15"/>
          <p:cNvSpPr txBox="1"/>
          <p:nvPr/>
        </p:nvSpPr>
        <p:spPr>
          <a:xfrm>
            <a:off x="2567608" y="2368625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A </a:t>
            </a:r>
            <a:endParaRPr lang="ja-JP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6060834" y="2348881"/>
            <a:ext cx="4672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B</a:t>
            </a:r>
            <a:endParaRPr lang="ja-JP" altLang="en-US" sz="11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605954" y="1507220"/>
            <a:ext cx="69408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Histological findings of the right ventricular </a:t>
            </a:r>
            <a:r>
              <a:rPr lang="en-US" altLang="ja-JP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endomyocardial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biopsy specimen </a:t>
            </a: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 2 weeks after admission</a:t>
            </a:r>
            <a:endParaRPr lang="ja-JP" altLang="en-US" sz="1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7360272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62</TotalTime>
  <Words>23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3_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nakano</cp:lastModifiedBy>
  <cp:revision>24</cp:revision>
  <cp:lastPrinted>2019-05-30T06:29:45Z</cp:lastPrinted>
  <dcterms:created xsi:type="dcterms:W3CDTF">2019-01-10T04:51:29Z</dcterms:created>
  <dcterms:modified xsi:type="dcterms:W3CDTF">2019-06-17T11:08:06Z</dcterms:modified>
</cp:coreProperties>
</file>